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18" r:id="rId2"/>
    <p:sldId id="319" r:id="rId3"/>
    <p:sldId id="320" r:id="rId4"/>
    <p:sldId id="322" r:id="rId5"/>
    <p:sldId id="321" r:id="rId6"/>
    <p:sldId id="323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U937 _ PCR" id="{B8B66164-71E5-464A-B735-D6D029DD387F}">
          <p14:sldIdLst>
            <p14:sldId id="318"/>
            <p14:sldId id="319"/>
            <p14:sldId id="320"/>
            <p14:sldId id="322"/>
            <p14:sldId id="321"/>
            <p14:sldId id="323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3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192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F004F9-EE4F-CCCC-D503-EC787D02F7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013E566-F0CA-2818-CA06-4D3174BCE5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5AFBDBF-EC6B-A215-8E34-1AE76F5FD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24E4FE6-C0EC-06CA-0A32-F0E7A0C324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EC5863-B16B-84FB-1766-2E9811672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93519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CDE93C-0109-4A4E-43B9-0213AAB99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AFB057-5F40-C5A2-22BB-83082ECF26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A0C880F-E7B2-B45F-F9E6-5528EEAC8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07A7B8-EE52-CE16-3974-123658791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60CAC97-288C-D931-0E74-B1D3B39AF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34399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CA04DD6C-9CE0-6944-D220-85FD0B84CD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01985CD-7FDF-DFC9-F521-5F5093D9E3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DE8D41D-5280-A3D2-35FE-6DE492A37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E2CD35F-96AF-B553-1190-6459645E2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470B3A7-2C66-ABD0-397F-1514780C2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393209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8A05D22-0906-24B0-A505-042093BA54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6B14401-B820-EC84-72ED-CFEA254031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D1C3AB-52E5-864F-5F62-555A5DA3E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9FDBB4-973B-7CE3-5C7A-B9A605E18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ED574F1-4230-8825-34FE-C0C752C2E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13618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44BB08-891A-F8A6-399A-F6BFE6A2EE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C673FAB-2826-A844-78E9-325AF3BC47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D564EAA-0533-1A03-A510-472A2580B9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0A3C6E6-8228-86F2-EB3B-618BBBC34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215B8C8-4B88-7140-0651-52CB422E6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50871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311744-2CD0-1421-838F-AF96034D33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8FC3610-6349-D665-74B8-F6FDCFFD30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BDDA4ED-4A71-A7F1-3CB6-E4BB0FB409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F140104-1B9B-9A48-09F8-3658E387E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12879F8-1173-DA5A-BA26-C74E3D163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6143ED8-B794-3F75-FA3A-980C879FB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20331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C5B8C77-2ED9-3A02-6279-A5201BBA6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96AFA86-1627-0BC3-7A51-F036FB815F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BB7686C-9CEC-9940-5F09-4219A79228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6D6D07CA-FA70-7D48-6BBC-CA38B63C54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9346B40-B84B-2EC6-A36F-E5775BC43D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703B204-6146-2C3F-CE3D-7B71F47BB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DEB459B-0C5C-6EA7-1E33-28A76AFAC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267179A-D674-0D5D-626D-7637DF68D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96461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9F502F-D271-44E4-E513-399113A6B6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6376AD6-C767-9E38-4662-82B7C44D9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6F8667F-B7BF-AC41-AD81-B8E1FE5CE3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A171E6E9-4202-793A-7FB7-191775912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92183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B4DCFA4-2BAA-03CB-3CC8-2ADBB49ED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8DF7362-C7CD-DF5A-A6AE-417FCF39CF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488B1C90-5D5A-F19A-3DEC-779E3B88E8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71090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07330C-265D-B470-C1AD-E34671A34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3072780-21CF-19DE-FE8F-2CC2CF51A8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78DD13C-D4FF-2165-D403-B28FA03CD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52B7F5D-AB50-9F7A-17C2-2A720D51A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474E21C-EA9C-E838-8445-82B659B11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7B7B1BD-0634-C2CD-7053-A69B64ACB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4916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D2A994D-2B37-3F13-37F1-7782FDE11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FB29955-698B-9925-1F40-935DD0FE4D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51C5572-9E3A-3B90-EAF0-21CF4FA66E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DD70FA7-CDE7-559C-C2BA-3419335F6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14C6416-1D16-4D38-FF3D-9A59B963E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F275C77-391B-84E4-58E3-2A43FA6EC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387604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9284F5F-5D84-9F9E-CCAD-29F5BF51BD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FB63952-785C-1245-F508-4A1B267223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4E34AD0-AD4D-E262-02B1-8D0E62A6C6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75A6CF-ED62-4384-AD2A-4C3FE448AC71}" type="datetimeFigureOut">
              <a:rPr lang="ko-KR" altLang="en-US" smtClean="0"/>
              <a:t>2024-10-20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4A698A3-763E-CD70-7B0B-B4B444A7AC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95B05E5-A1F3-2636-1A37-E8FD0EF3E3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851742-5861-46A1-B33C-C8D32EFA1988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51100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4.png"/><Relationship Id="rId7" Type="http://schemas.microsoft.com/office/2007/relationships/hdphoto" Target="../media/hdphoto1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Relationship Id="rId9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2.png"/><Relationship Id="rId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162375" y="1195777"/>
            <a:ext cx="1419966" cy="52322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GAPDH</a:t>
            </a:r>
          </a:p>
          <a:p>
            <a:pPr algn="ctr"/>
            <a:r>
              <a:rPr lang="en-US" altLang="ko-KR" sz="1400" b="1" dirty="0"/>
              <a:t>(28cycle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418549" y="2073165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et 1</a:t>
            </a:r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418549" y="2825733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et 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418549" y="3578301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et 3</a:t>
            </a:r>
            <a:endParaRPr lang="ko-KR" alt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7220D304-9048-4A2C-802D-3F39D452C41B}"/>
              </a:ext>
            </a:extLst>
          </p:cNvPr>
          <p:cNvSpPr txBox="1"/>
          <p:nvPr/>
        </p:nvSpPr>
        <p:spPr>
          <a:xfrm>
            <a:off x="354428" y="615743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</a:t>
            </a:r>
            <a:r>
              <a:rPr lang="ko-KR" altLang="en-US" dirty="0"/>
              <a:t>대표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APDH ; Loading control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8648129" y="61507"/>
            <a:ext cx="3446526" cy="1200329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Tx/>
              <a:buChar char="-"/>
            </a:pPr>
            <a:r>
              <a:rPr lang="en-US" altLang="ko-KR" sz="1200" dirty="0"/>
              <a:t>CTRL ; Control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 + Myokine (Irisin, Oncostatin M)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 + Genistein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 + Myokine + Genistein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BF97FC78-FEEC-450A-8E2F-F2DCEB9C77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6862" y="2038891"/>
            <a:ext cx="4781550" cy="495300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02BE6762-B0B9-481C-B6AF-ED0B7699AC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4943" y="2038891"/>
            <a:ext cx="5226996" cy="49530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6CE261D4-7226-4670-BE64-05C187B5F65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06862" y="2823355"/>
            <a:ext cx="4777092" cy="483396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123E0183-7069-407D-9BB5-01222110E5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84943" y="2793637"/>
            <a:ext cx="5226996" cy="545147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C9783961-4FAF-4FF0-A742-F2CE43D9A6C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3876"/>
          <a:stretch/>
        </p:blipFill>
        <p:spPr>
          <a:xfrm>
            <a:off x="6784944" y="3541738"/>
            <a:ext cx="5226995" cy="540203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48880183-0D5D-4C24-8C7A-F68812845FE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06861" y="3560855"/>
            <a:ext cx="4777092" cy="458516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942048C3-71B1-4B03-B65B-B81C1DB5F6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2404" y="6094454"/>
            <a:ext cx="4781550" cy="49530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04E035E8-197E-4FCF-AF39-0BEB7C9DE7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4943" y="6086643"/>
            <a:ext cx="5226996" cy="4953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7D37FF9-36E7-415A-BD8E-4BA8A38C3BAC}"/>
              </a:ext>
            </a:extLst>
          </p:cNvPr>
          <p:cNvSpPr txBox="1"/>
          <p:nvPr/>
        </p:nvSpPr>
        <p:spPr>
          <a:xfrm>
            <a:off x="725779" y="4213188"/>
            <a:ext cx="570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A089549-85C1-4584-AC4D-0E541BD19A89}"/>
              </a:ext>
            </a:extLst>
          </p:cNvPr>
          <p:cNvSpPr txBox="1"/>
          <p:nvPr/>
        </p:nvSpPr>
        <p:spPr>
          <a:xfrm>
            <a:off x="751493" y="457436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C908F68-A7F2-41D8-AB65-B13A27173660}"/>
              </a:ext>
            </a:extLst>
          </p:cNvPr>
          <p:cNvSpPr txBox="1"/>
          <p:nvPr/>
        </p:nvSpPr>
        <p:spPr>
          <a:xfrm>
            <a:off x="674549" y="4935550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risin</a:t>
            </a:r>
            <a:endParaRPr lang="ko-KR" altLang="en-US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31B051D-F911-4726-A014-19FBF3B3ACA0}"/>
              </a:ext>
            </a:extLst>
          </p:cNvPr>
          <p:cNvSpPr txBox="1"/>
          <p:nvPr/>
        </p:nvSpPr>
        <p:spPr>
          <a:xfrm>
            <a:off x="360179" y="5316657"/>
            <a:ext cx="941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10" name="표 9">
            <a:extLst>
              <a:ext uri="{FF2B5EF4-FFF2-40B4-BE49-F238E27FC236}">
                <a16:creationId xmlns:a16="http://schemas.microsoft.com/office/drawing/2014/main" id="{29FB26A7-BAEE-4F21-8CEB-9AFE5B77DCE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52757101"/>
              </p:ext>
            </p:extLst>
          </p:nvPr>
        </p:nvGraphicFramePr>
        <p:xfrm>
          <a:off x="1229061" y="4192216"/>
          <a:ext cx="4754892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92482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792482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792482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792482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792482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792482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24469517-EC65-4C74-957E-DAD3C34705A1}"/>
              </a:ext>
            </a:extLst>
          </p:cNvPr>
          <p:cNvSpPr txBox="1"/>
          <p:nvPr/>
        </p:nvSpPr>
        <p:spPr>
          <a:xfrm>
            <a:off x="6477000" y="4213187"/>
            <a:ext cx="570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1C6F52F-CE4A-4949-A722-0616E8307D7C}"/>
              </a:ext>
            </a:extLst>
          </p:cNvPr>
          <p:cNvSpPr txBox="1"/>
          <p:nvPr/>
        </p:nvSpPr>
        <p:spPr>
          <a:xfrm>
            <a:off x="6516273" y="457436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589D6FD-0082-406B-969B-1863B0F09636}"/>
              </a:ext>
            </a:extLst>
          </p:cNvPr>
          <p:cNvSpPr txBox="1"/>
          <p:nvPr/>
        </p:nvSpPr>
        <p:spPr>
          <a:xfrm>
            <a:off x="5775815" y="4971139"/>
            <a:ext cx="12939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Oncostatin M</a:t>
            </a:r>
            <a:endParaRPr lang="ko-KR" altLang="en-US"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68D85E3-508E-4027-A1E2-B8ED40197BA4}"/>
              </a:ext>
            </a:extLst>
          </p:cNvPr>
          <p:cNvSpPr txBox="1"/>
          <p:nvPr/>
        </p:nvSpPr>
        <p:spPr>
          <a:xfrm>
            <a:off x="6121363" y="5337328"/>
            <a:ext cx="941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30" name="표 29">
            <a:extLst>
              <a:ext uri="{FF2B5EF4-FFF2-40B4-BE49-F238E27FC236}">
                <a16:creationId xmlns:a16="http://schemas.microsoft.com/office/drawing/2014/main" id="{3B0CFA5E-0AB9-4CED-8D57-A11F0E7B5F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2230869"/>
              </p:ext>
            </p:extLst>
          </p:nvPr>
        </p:nvGraphicFramePr>
        <p:xfrm>
          <a:off x="6902969" y="4204030"/>
          <a:ext cx="499094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31824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38291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8">
            <a:extLst>
              <a:ext uri="{FF2B5EF4-FFF2-40B4-BE49-F238E27FC236}">
                <a16:creationId xmlns:a16="http://schemas.microsoft.com/office/drawing/2014/main" id="{CDCD6DFA-04FA-C198-1B57-D6D5B4713D72}"/>
              </a:ext>
            </a:extLst>
          </p:cNvPr>
          <p:cNvSpPr txBox="1"/>
          <p:nvPr/>
        </p:nvSpPr>
        <p:spPr>
          <a:xfrm>
            <a:off x="162375" y="1195777"/>
            <a:ext cx="1419966" cy="52322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CD163</a:t>
            </a:r>
          </a:p>
          <a:p>
            <a:pPr algn="ctr"/>
            <a:r>
              <a:rPr lang="en-US" altLang="ko-KR" sz="1400" b="1" dirty="0"/>
              <a:t>(28cycle)</a:t>
            </a:r>
          </a:p>
        </p:txBody>
      </p:sp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D163 ; M2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8648129" y="61507"/>
            <a:ext cx="3446526" cy="1200329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Tx/>
              <a:buChar char="-"/>
            </a:pPr>
            <a:r>
              <a:rPr lang="en-US" altLang="ko-KR" sz="1200" dirty="0"/>
              <a:t>CTRL ; Control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 + Myokine (Irisin, Oncostatin M)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 + Genistein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 + Myokine + Genistei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1228B7D-AAC2-485B-8D93-3F902F6EF049}"/>
              </a:ext>
            </a:extLst>
          </p:cNvPr>
          <p:cNvSpPr txBox="1"/>
          <p:nvPr/>
        </p:nvSpPr>
        <p:spPr>
          <a:xfrm>
            <a:off x="418549" y="2073165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et 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79161C1-23BA-4315-B156-41AC4629B573}"/>
              </a:ext>
            </a:extLst>
          </p:cNvPr>
          <p:cNvSpPr txBox="1"/>
          <p:nvPr/>
        </p:nvSpPr>
        <p:spPr>
          <a:xfrm>
            <a:off x="418549" y="2771225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et 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DD97C5F-B3E8-4BB7-9D1A-66DF77964810}"/>
              </a:ext>
            </a:extLst>
          </p:cNvPr>
          <p:cNvSpPr txBox="1"/>
          <p:nvPr/>
        </p:nvSpPr>
        <p:spPr>
          <a:xfrm>
            <a:off x="418549" y="3452835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et 3</a:t>
            </a:r>
            <a:endParaRPr lang="ko-KR" altLang="en-US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EC3B454B-8B6F-4BD4-9878-B222A2C478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61391" y="1947854"/>
            <a:ext cx="5073561" cy="583460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E2AE212F-016D-4389-9258-3CBF64512D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2624" y="1955489"/>
            <a:ext cx="4919499" cy="584495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AAC8796D-2EF7-4EA5-9ED3-EF34289798A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1451"/>
          <a:stretch/>
        </p:blipFill>
        <p:spPr>
          <a:xfrm>
            <a:off x="1296769" y="2711586"/>
            <a:ext cx="4919499" cy="537797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9128C273-53C3-48E5-811C-135055FE559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61391" y="2711586"/>
            <a:ext cx="5073560" cy="537797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71C34CD-932E-4DB7-A43B-AC5EF937F6AA}"/>
              </a:ext>
            </a:extLst>
          </p:cNvPr>
          <p:cNvSpPr txBox="1"/>
          <p:nvPr/>
        </p:nvSpPr>
        <p:spPr>
          <a:xfrm>
            <a:off x="725779" y="4213188"/>
            <a:ext cx="570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596887E-5A09-496F-AF1F-E4034BE67CE5}"/>
              </a:ext>
            </a:extLst>
          </p:cNvPr>
          <p:cNvSpPr txBox="1"/>
          <p:nvPr/>
        </p:nvSpPr>
        <p:spPr>
          <a:xfrm>
            <a:off x="751493" y="457436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598A26C-21D1-488D-B998-7CE2552EFFEB}"/>
              </a:ext>
            </a:extLst>
          </p:cNvPr>
          <p:cNvSpPr txBox="1"/>
          <p:nvPr/>
        </p:nvSpPr>
        <p:spPr>
          <a:xfrm>
            <a:off x="674549" y="4935550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risin</a:t>
            </a:r>
            <a:endParaRPr lang="ko-KR" altLang="en-US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504E741-B967-466C-8B4E-AF4127F78500}"/>
              </a:ext>
            </a:extLst>
          </p:cNvPr>
          <p:cNvSpPr txBox="1"/>
          <p:nvPr/>
        </p:nvSpPr>
        <p:spPr>
          <a:xfrm>
            <a:off x="360179" y="5316657"/>
            <a:ext cx="941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24" name="표 23">
            <a:extLst>
              <a:ext uri="{FF2B5EF4-FFF2-40B4-BE49-F238E27FC236}">
                <a16:creationId xmlns:a16="http://schemas.microsoft.com/office/drawing/2014/main" id="{1DBE9E05-A53A-4DCD-89EB-CD1F6E166A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6721451"/>
              </p:ext>
            </p:extLst>
          </p:nvPr>
        </p:nvGraphicFramePr>
        <p:xfrm>
          <a:off x="1281662" y="4192214"/>
          <a:ext cx="4919502" cy="150823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19917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770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770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770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770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DABB5494-F22B-4788-AF48-27A4540B96D8}"/>
              </a:ext>
            </a:extLst>
          </p:cNvPr>
          <p:cNvSpPr txBox="1"/>
          <p:nvPr/>
        </p:nvSpPr>
        <p:spPr>
          <a:xfrm>
            <a:off x="6371899" y="4213187"/>
            <a:ext cx="570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B0AC084-DF9E-47F0-8449-B33B1E7CE7C4}"/>
              </a:ext>
            </a:extLst>
          </p:cNvPr>
          <p:cNvSpPr txBox="1"/>
          <p:nvPr/>
        </p:nvSpPr>
        <p:spPr>
          <a:xfrm>
            <a:off x="6411172" y="457436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561D263-F9DE-4FB9-A200-A324CA01ACC0}"/>
              </a:ext>
            </a:extLst>
          </p:cNvPr>
          <p:cNvSpPr txBox="1"/>
          <p:nvPr/>
        </p:nvSpPr>
        <p:spPr>
          <a:xfrm>
            <a:off x="6328197" y="4977464"/>
            <a:ext cx="601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OSM</a:t>
            </a:r>
            <a:endParaRPr lang="ko-KR" altLang="en-US"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D3204DE-ACC1-427B-9D1C-D134F61163A8}"/>
              </a:ext>
            </a:extLst>
          </p:cNvPr>
          <p:cNvSpPr txBox="1"/>
          <p:nvPr/>
        </p:nvSpPr>
        <p:spPr>
          <a:xfrm>
            <a:off x="6016262" y="5337328"/>
            <a:ext cx="941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29" name="표 28">
            <a:extLst>
              <a:ext uri="{FF2B5EF4-FFF2-40B4-BE49-F238E27FC236}">
                <a16:creationId xmlns:a16="http://schemas.microsoft.com/office/drawing/2014/main" id="{5D714217-78F5-4944-9B3E-6BF8A10BCA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1839539"/>
              </p:ext>
            </p:extLst>
          </p:nvPr>
        </p:nvGraphicFramePr>
        <p:xfrm>
          <a:off x="6757047" y="4214812"/>
          <a:ext cx="499094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31824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CAB2EC8B-BD80-4E24-B179-0185472387D9}"/>
              </a:ext>
            </a:extLst>
          </p:cNvPr>
          <p:cNvSpPr txBox="1"/>
          <p:nvPr/>
        </p:nvSpPr>
        <p:spPr>
          <a:xfrm>
            <a:off x="354428" y="615743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</a:t>
            </a:r>
            <a:r>
              <a:rPr lang="ko-KR" altLang="en-US" dirty="0"/>
              <a:t>대표</a:t>
            </a: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72290DC9-1945-40CC-98AD-CA9284818A6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86258" y="3439151"/>
            <a:ext cx="4919499" cy="541145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DFDDF827-F9A4-43DF-BFBB-828D85447A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61391" y="3429792"/>
            <a:ext cx="5073559" cy="558091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D5BC6609-6588-4B3B-8DC4-F767C4642C9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96769" y="6098241"/>
            <a:ext cx="4919499" cy="541145"/>
          </a:xfrm>
          <a:prstGeom prst="rect">
            <a:avLst/>
          </a:prstGeom>
        </p:spPr>
      </p:pic>
      <p:pic>
        <p:nvPicPr>
          <p:cNvPr id="32" name="그림 31">
            <a:extLst>
              <a:ext uri="{FF2B5EF4-FFF2-40B4-BE49-F238E27FC236}">
                <a16:creationId xmlns:a16="http://schemas.microsoft.com/office/drawing/2014/main" id="{4390E795-C503-431E-A48E-C0CB7C0D2B2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561390" y="6081295"/>
            <a:ext cx="5073559" cy="5580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8110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직사각형 37">
            <a:extLst>
              <a:ext uri="{FF2B5EF4-FFF2-40B4-BE49-F238E27FC236}">
                <a16:creationId xmlns:a16="http://schemas.microsoft.com/office/drawing/2014/main" id="{61038681-7E22-4175-BFF2-0D2C30F782E1}"/>
              </a:ext>
            </a:extLst>
          </p:cNvPr>
          <p:cNvSpPr/>
          <p:nvPr/>
        </p:nvSpPr>
        <p:spPr>
          <a:xfrm>
            <a:off x="0" y="-1"/>
            <a:ext cx="1744717" cy="39939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>
                <a:solidFill>
                  <a:schemeClr val="tx1"/>
                </a:solidFill>
              </a:rPr>
              <a:t>PCR Data</a:t>
            </a:r>
            <a:endParaRPr lang="ko-KR" altLang="en-US" sz="1700" b="1" dirty="0">
              <a:solidFill>
                <a:schemeClr val="tx1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B900486-1C81-465C-BCF5-35F88248A65B}"/>
              </a:ext>
            </a:extLst>
          </p:cNvPr>
          <p:cNvSpPr txBox="1"/>
          <p:nvPr/>
        </p:nvSpPr>
        <p:spPr>
          <a:xfrm>
            <a:off x="1802905" y="23732"/>
            <a:ext cx="397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solidFill>
                  <a:srgbClr val="00206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rg1 ; M2 macrophage marker</a:t>
            </a:r>
            <a:endParaRPr lang="en-US" altLang="ko-KR" sz="1400" b="1" i="1" dirty="0">
              <a:solidFill>
                <a:srgbClr val="00206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8648129" y="61507"/>
            <a:ext cx="3446526" cy="1200329"/>
          </a:xfrm>
          <a:prstGeom prst="rect">
            <a:avLst/>
          </a:prstGeom>
          <a:noFill/>
          <a:ln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pPr marL="171450" indent="-171450">
              <a:buFontTx/>
              <a:buChar char="-"/>
            </a:pPr>
            <a:r>
              <a:rPr lang="en-US" altLang="ko-KR" sz="1200" dirty="0"/>
              <a:t>CTRL ; Control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 + Myokine (Irisin, Oncostatin M)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 + Genistein</a:t>
            </a:r>
          </a:p>
          <a:p>
            <a:pPr marL="171450" indent="-171450">
              <a:buFontTx/>
              <a:buChar char="-"/>
            </a:pPr>
            <a:r>
              <a:rPr lang="en-US" altLang="ko-KR" sz="1200" dirty="0"/>
              <a:t>PMA + IL-4 + Myokine + Genistein</a:t>
            </a:r>
          </a:p>
        </p:txBody>
      </p:sp>
      <p:sp>
        <p:nvSpPr>
          <p:cNvPr id="64" name="TextBox 8">
            <a:extLst>
              <a:ext uri="{FF2B5EF4-FFF2-40B4-BE49-F238E27FC236}">
                <a16:creationId xmlns:a16="http://schemas.microsoft.com/office/drawing/2014/main" id="{3EB8418F-745D-4A13-BACF-F2D895B2F1B5}"/>
              </a:ext>
            </a:extLst>
          </p:cNvPr>
          <p:cNvSpPr txBox="1"/>
          <p:nvPr/>
        </p:nvSpPr>
        <p:spPr>
          <a:xfrm>
            <a:off x="162375" y="1195777"/>
            <a:ext cx="1419966" cy="523220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1400" b="1" dirty="0"/>
              <a:t>Arg1</a:t>
            </a:r>
          </a:p>
          <a:p>
            <a:pPr algn="ctr"/>
            <a:r>
              <a:rPr lang="en-US" altLang="ko-KR" sz="1400" b="1" dirty="0"/>
              <a:t>(28cycle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0DA5546-130E-47D1-AFBD-4EF7B6DBF4FF}"/>
              </a:ext>
            </a:extLst>
          </p:cNvPr>
          <p:cNvSpPr txBox="1"/>
          <p:nvPr/>
        </p:nvSpPr>
        <p:spPr>
          <a:xfrm>
            <a:off x="418549" y="2073165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et 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421A25C4-F09B-44F4-BD5E-EE8C47F2234E}"/>
              </a:ext>
            </a:extLst>
          </p:cNvPr>
          <p:cNvSpPr txBox="1"/>
          <p:nvPr/>
        </p:nvSpPr>
        <p:spPr>
          <a:xfrm>
            <a:off x="418549" y="2825733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et 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7023F13-B053-4F18-9C03-AC6FECD6A342}"/>
              </a:ext>
            </a:extLst>
          </p:cNvPr>
          <p:cNvSpPr txBox="1"/>
          <p:nvPr/>
        </p:nvSpPr>
        <p:spPr>
          <a:xfrm>
            <a:off x="418549" y="3578301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et 3</a:t>
            </a:r>
            <a:endParaRPr lang="ko-KR" altLang="en-US" dirty="0"/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4C08AA9C-128F-4327-8AC8-87D5DF956F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2001705"/>
            <a:ext cx="4772634" cy="543940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8B7C0D30-F38B-4BC1-8123-346B756442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08226" y="1998760"/>
            <a:ext cx="5153025" cy="590550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4EB99A70-638D-433D-9BFC-12932361435F}"/>
              </a:ext>
            </a:extLst>
          </p:cNvPr>
          <p:cNvSpPr txBox="1"/>
          <p:nvPr/>
        </p:nvSpPr>
        <p:spPr>
          <a:xfrm>
            <a:off x="354428" y="615743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#</a:t>
            </a:r>
            <a:r>
              <a:rPr lang="ko-KR" altLang="en-US" dirty="0"/>
              <a:t>대표</a:t>
            </a: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CC22B858-B959-4BAA-8207-3457521996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95400" y="2747016"/>
            <a:ext cx="4772634" cy="493351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D4411A54-8E1B-4844-B5C5-C2E3A4C89C5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-382" b="17898"/>
          <a:stretch/>
        </p:blipFill>
        <p:spPr>
          <a:xfrm>
            <a:off x="6708225" y="2744608"/>
            <a:ext cx="5153025" cy="493351"/>
          </a:xfrm>
          <a:prstGeom prst="rect">
            <a:avLst/>
          </a:prstGeom>
        </p:spPr>
      </p:pic>
      <p:pic>
        <p:nvPicPr>
          <p:cNvPr id="6" name="그림 5">
            <a:extLst>
              <a:ext uri="{FF2B5EF4-FFF2-40B4-BE49-F238E27FC236}">
                <a16:creationId xmlns:a16="http://schemas.microsoft.com/office/drawing/2014/main" id="{7EA13FEC-63FB-459E-B2EA-B821577B4C4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95400" y="3499958"/>
            <a:ext cx="4772634" cy="553861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E2B09537-6566-41CE-B4DC-BEC3797B783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706893" y="3499118"/>
            <a:ext cx="5153025" cy="541761"/>
          </a:xfrm>
          <a:prstGeom prst="rect">
            <a:avLst/>
          </a:prstGeom>
        </p:spPr>
      </p:pic>
      <p:pic>
        <p:nvPicPr>
          <p:cNvPr id="28" name="그림 27">
            <a:extLst>
              <a:ext uri="{FF2B5EF4-FFF2-40B4-BE49-F238E27FC236}">
                <a16:creationId xmlns:a16="http://schemas.microsoft.com/office/drawing/2014/main" id="{7D9C1010-C6C1-4404-A34D-77C963899F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5400" y="6063165"/>
            <a:ext cx="4772634" cy="543940"/>
          </a:xfrm>
          <a:prstGeom prst="rect">
            <a:avLst/>
          </a:prstGeom>
        </p:spPr>
      </p:pic>
      <p:pic>
        <p:nvPicPr>
          <p:cNvPr id="29" name="그림 28">
            <a:extLst>
              <a:ext uri="{FF2B5EF4-FFF2-40B4-BE49-F238E27FC236}">
                <a16:creationId xmlns:a16="http://schemas.microsoft.com/office/drawing/2014/main" id="{EC9C2311-11F2-4186-A0E8-46A0603ACA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06893" y="6046829"/>
            <a:ext cx="5153025" cy="59055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A14F83D7-6CD1-47BB-873B-D12208A90C35}"/>
              </a:ext>
            </a:extLst>
          </p:cNvPr>
          <p:cNvSpPr txBox="1"/>
          <p:nvPr/>
        </p:nvSpPr>
        <p:spPr>
          <a:xfrm>
            <a:off x="725779" y="4213188"/>
            <a:ext cx="570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2E565DA-5468-421D-88DA-88B8D1B277FB}"/>
              </a:ext>
            </a:extLst>
          </p:cNvPr>
          <p:cNvSpPr txBox="1"/>
          <p:nvPr/>
        </p:nvSpPr>
        <p:spPr>
          <a:xfrm>
            <a:off x="751493" y="457436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BE9AB78-0D8C-43F8-B0A5-B860A6533FD3}"/>
              </a:ext>
            </a:extLst>
          </p:cNvPr>
          <p:cNvSpPr txBox="1"/>
          <p:nvPr/>
        </p:nvSpPr>
        <p:spPr>
          <a:xfrm>
            <a:off x="674549" y="4935550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risin</a:t>
            </a:r>
            <a:endParaRPr lang="ko-KR" altLang="en-US"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08447C-D090-446E-A371-480243F2027E}"/>
              </a:ext>
            </a:extLst>
          </p:cNvPr>
          <p:cNvSpPr txBox="1"/>
          <p:nvPr/>
        </p:nvSpPr>
        <p:spPr>
          <a:xfrm>
            <a:off x="360179" y="5316657"/>
            <a:ext cx="941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34" name="표 33">
            <a:extLst>
              <a:ext uri="{FF2B5EF4-FFF2-40B4-BE49-F238E27FC236}">
                <a16:creationId xmlns:a16="http://schemas.microsoft.com/office/drawing/2014/main" id="{41BCF9FE-123D-4B94-9CF2-BD8DF81A45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6462582"/>
              </p:ext>
            </p:extLst>
          </p:nvPr>
        </p:nvGraphicFramePr>
        <p:xfrm>
          <a:off x="1281662" y="4192214"/>
          <a:ext cx="4919502" cy="150823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19917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819917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770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770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770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7705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DD3E291B-19F9-4B79-BAF5-C3A1E6D982ED}"/>
              </a:ext>
            </a:extLst>
          </p:cNvPr>
          <p:cNvSpPr txBox="1"/>
          <p:nvPr/>
        </p:nvSpPr>
        <p:spPr>
          <a:xfrm>
            <a:off x="6392919" y="4213187"/>
            <a:ext cx="570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</a:t>
            </a:r>
            <a:endParaRPr lang="ko-KR" altLang="en-US" sz="14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DAF5A98-2E3C-49E8-972D-1CA75B67C3B8}"/>
              </a:ext>
            </a:extLst>
          </p:cNvPr>
          <p:cNvSpPr txBox="1"/>
          <p:nvPr/>
        </p:nvSpPr>
        <p:spPr>
          <a:xfrm>
            <a:off x="6432192" y="4574369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</a:t>
            </a:r>
            <a:endParaRPr lang="ko-KR" altLang="en-US" sz="1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6D36B2D-3243-47EA-800E-C6C7E55AC8AF}"/>
              </a:ext>
            </a:extLst>
          </p:cNvPr>
          <p:cNvSpPr txBox="1"/>
          <p:nvPr/>
        </p:nvSpPr>
        <p:spPr>
          <a:xfrm>
            <a:off x="6349217" y="4977464"/>
            <a:ext cx="6018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OSM</a:t>
            </a:r>
            <a:endParaRPr lang="ko-KR" altLang="en-US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525081C-BA18-4194-A7F6-6D4269A45279}"/>
              </a:ext>
            </a:extLst>
          </p:cNvPr>
          <p:cNvSpPr txBox="1"/>
          <p:nvPr/>
        </p:nvSpPr>
        <p:spPr>
          <a:xfrm>
            <a:off x="6016262" y="5337328"/>
            <a:ext cx="9414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</a:t>
            </a:r>
            <a:endParaRPr lang="ko-KR" altLang="en-US" sz="1400" dirty="0"/>
          </a:p>
        </p:txBody>
      </p:sp>
      <p:graphicFrame>
        <p:nvGraphicFramePr>
          <p:cNvPr id="41" name="표 40">
            <a:extLst>
              <a:ext uri="{FF2B5EF4-FFF2-40B4-BE49-F238E27FC236}">
                <a16:creationId xmlns:a16="http://schemas.microsoft.com/office/drawing/2014/main" id="{FFF44870-7292-4910-B2C2-C06B5EA3D5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48998868"/>
              </p:ext>
            </p:extLst>
          </p:nvPr>
        </p:nvGraphicFramePr>
        <p:xfrm>
          <a:off x="6820109" y="4214812"/>
          <a:ext cx="499094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31824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831824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1821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608492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9FD999F8-3FCA-482B-8248-684EC2F245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82047" y="1002951"/>
            <a:ext cx="4382083" cy="2665767"/>
          </a:xfrm>
          <a:prstGeom prst="rect">
            <a:avLst/>
          </a:prstGeom>
        </p:spPr>
      </p:pic>
      <p:graphicFrame>
        <p:nvGraphicFramePr>
          <p:cNvPr id="12" name="표 11">
            <a:extLst>
              <a:ext uri="{FF2B5EF4-FFF2-40B4-BE49-F238E27FC236}">
                <a16:creationId xmlns:a16="http://schemas.microsoft.com/office/drawing/2014/main" id="{75C5032B-65BF-436D-B9E6-A1F5906FB1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1230824"/>
              </p:ext>
            </p:extLst>
          </p:nvPr>
        </p:nvGraphicFramePr>
        <p:xfrm>
          <a:off x="7696359" y="3554184"/>
          <a:ext cx="327893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648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aphicFrame>
        <p:nvGraphicFramePr>
          <p:cNvPr id="17" name="표 16">
            <a:extLst>
              <a:ext uri="{FF2B5EF4-FFF2-40B4-BE49-F238E27FC236}">
                <a16:creationId xmlns:a16="http://schemas.microsoft.com/office/drawing/2014/main" id="{2B763AC2-2DD8-4889-A2DC-FDDB387AE4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4915140"/>
              </p:ext>
            </p:extLst>
          </p:nvPr>
        </p:nvGraphicFramePr>
        <p:xfrm>
          <a:off x="2144836" y="3578730"/>
          <a:ext cx="327893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648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pic>
        <p:nvPicPr>
          <p:cNvPr id="3" name="그림 2">
            <a:extLst>
              <a:ext uri="{FF2B5EF4-FFF2-40B4-BE49-F238E27FC236}">
                <a16:creationId xmlns:a16="http://schemas.microsoft.com/office/drawing/2014/main" id="{FAE5915E-23A7-4D0D-A2FA-72B06B1A09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30524" y="1078620"/>
            <a:ext cx="4293246" cy="2559780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40612BD-EF43-4EC8-9F15-BF8EC74DBBC7}"/>
              </a:ext>
            </a:extLst>
          </p:cNvPr>
          <p:cNvSpPr txBox="1"/>
          <p:nvPr/>
        </p:nvSpPr>
        <p:spPr>
          <a:xfrm>
            <a:off x="6190949" y="3619601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6D10AAC-5C62-4C1A-8F03-D998A6137C93}"/>
              </a:ext>
            </a:extLst>
          </p:cNvPr>
          <p:cNvSpPr txBox="1"/>
          <p:nvPr/>
        </p:nvSpPr>
        <p:spPr>
          <a:xfrm>
            <a:off x="6264927" y="3981361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0E17E1A-10F7-46E9-8DAA-5BAAE67BAF6F}"/>
              </a:ext>
            </a:extLst>
          </p:cNvPr>
          <p:cNvSpPr txBox="1"/>
          <p:nvPr/>
        </p:nvSpPr>
        <p:spPr>
          <a:xfrm>
            <a:off x="6435815" y="4343121"/>
            <a:ext cx="12715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risin (20 nM)</a:t>
            </a:r>
            <a:endParaRPr lang="ko-KR" altLang="en-US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94FD61D-1DB6-4A37-AECC-184FA3730D70}"/>
              </a:ext>
            </a:extLst>
          </p:cNvPr>
          <p:cNvSpPr txBox="1"/>
          <p:nvPr/>
        </p:nvSpPr>
        <p:spPr>
          <a:xfrm>
            <a:off x="6074042" y="4688624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B926A77-41D0-441C-8A22-6740DB82BDC4}"/>
              </a:ext>
            </a:extLst>
          </p:cNvPr>
          <p:cNvSpPr txBox="1"/>
          <p:nvPr/>
        </p:nvSpPr>
        <p:spPr>
          <a:xfrm>
            <a:off x="641693" y="3638400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2243B6A-38D9-4AD0-9183-C6A1F6E244EB}"/>
              </a:ext>
            </a:extLst>
          </p:cNvPr>
          <p:cNvSpPr txBox="1"/>
          <p:nvPr/>
        </p:nvSpPr>
        <p:spPr>
          <a:xfrm>
            <a:off x="715671" y="4000160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990121B-7086-4651-AAD1-DC57EFABE180}"/>
              </a:ext>
            </a:extLst>
          </p:cNvPr>
          <p:cNvSpPr txBox="1"/>
          <p:nvPr/>
        </p:nvSpPr>
        <p:spPr>
          <a:xfrm>
            <a:off x="886559" y="4361920"/>
            <a:ext cx="12715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risin (20 nM)</a:t>
            </a:r>
            <a:endParaRPr lang="ko-KR" altLang="en-US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6266087-124A-4585-8B3E-A3FAB246B643}"/>
              </a:ext>
            </a:extLst>
          </p:cNvPr>
          <p:cNvSpPr txBox="1"/>
          <p:nvPr/>
        </p:nvSpPr>
        <p:spPr>
          <a:xfrm>
            <a:off x="524786" y="4707423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671849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5498A69A-472C-4B19-9DC3-535521DAE3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84711" y="1080784"/>
            <a:ext cx="4450515" cy="2609241"/>
          </a:xfrm>
          <a:prstGeom prst="rect">
            <a:avLst/>
          </a:prstGeom>
        </p:spPr>
      </p:pic>
      <p:graphicFrame>
        <p:nvGraphicFramePr>
          <p:cNvPr id="12" name="표 11">
            <a:extLst>
              <a:ext uri="{FF2B5EF4-FFF2-40B4-BE49-F238E27FC236}">
                <a16:creationId xmlns:a16="http://schemas.microsoft.com/office/drawing/2014/main" id="{75C5032B-65BF-436D-B9E6-A1F5906FB1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5203558"/>
              </p:ext>
            </p:extLst>
          </p:nvPr>
        </p:nvGraphicFramePr>
        <p:xfrm>
          <a:off x="7799023" y="3652040"/>
          <a:ext cx="327893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648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graphicFrame>
        <p:nvGraphicFramePr>
          <p:cNvPr id="17" name="표 16">
            <a:extLst>
              <a:ext uri="{FF2B5EF4-FFF2-40B4-BE49-F238E27FC236}">
                <a16:creationId xmlns:a16="http://schemas.microsoft.com/office/drawing/2014/main" id="{2B763AC2-2DD8-4889-A2DC-FDDB387AE4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7343700"/>
              </p:ext>
            </p:extLst>
          </p:nvPr>
        </p:nvGraphicFramePr>
        <p:xfrm>
          <a:off x="2128355" y="3743485"/>
          <a:ext cx="3278934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6489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546489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5545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pic>
        <p:nvPicPr>
          <p:cNvPr id="21" name="그림 20">
            <a:extLst>
              <a:ext uri="{FF2B5EF4-FFF2-40B4-BE49-F238E27FC236}">
                <a16:creationId xmlns:a16="http://schemas.microsoft.com/office/drawing/2014/main" id="{EC6EA678-C9AE-47E7-BF1E-4D180C37ACE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4043" y="1080784"/>
            <a:ext cx="4450515" cy="266270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160DA4A-C224-4A41-AA53-12FDE9BEA984}"/>
              </a:ext>
            </a:extLst>
          </p:cNvPr>
          <p:cNvSpPr txBox="1"/>
          <p:nvPr/>
        </p:nvSpPr>
        <p:spPr>
          <a:xfrm>
            <a:off x="6331603" y="4444739"/>
            <a:ext cx="1531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OSM (20 ng/mL)</a:t>
            </a:r>
            <a:endParaRPr lang="ko-KR" altLang="en-US" sz="14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15F048D-DA33-4D8B-800B-E56B6047ED5F}"/>
              </a:ext>
            </a:extLst>
          </p:cNvPr>
          <p:cNvSpPr txBox="1"/>
          <p:nvPr/>
        </p:nvSpPr>
        <p:spPr>
          <a:xfrm>
            <a:off x="6331603" y="3729362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52ADC5D-11E4-4D56-9635-5D622CB55F66}"/>
              </a:ext>
            </a:extLst>
          </p:cNvPr>
          <p:cNvSpPr txBox="1"/>
          <p:nvPr/>
        </p:nvSpPr>
        <p:spPr>
          <a:xfrm>
            <a:off x="6418634" y="4102035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7FFC7F2-31D8-4095-9DFD-667B6F60413A}"/>
              </a:ext>
            </a:extLst>
          </p:cNvPr>
          <p:cNvSpPr txBox="1"/>
          <p:nvPr/>
        </p:nvSpPr>
        <p:spPr>
          <a:xfrm>
            <a:off x="6246037" y="4793494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683D33C-569F-4533-9ACC-376964F88DC8}"/>
              </a:ext>
            </a:extLst>
          </p:cNvPr>
          <p:cNvSpPr txBox="1"/>
          <p:nvPr/>
        </p:nvSpPr>
        <p:spPr>
          <a:xfrm>
            <a:off x="600295" y="4545328"/>
            <a:ext cx="1531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OSM (20 ng/mL)</a:t>
            </a:r>
            <a:endParaRPr lang="ko-KR" altLang="en-US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C17797A-E1C9-481A-AED1-BA9EEE9EAE87}"/>
              </a:ext>
            </a:extLst>
          </p:cNvPr>
          <p:cNvSpPr txBox="1"/>
          <p:nvPr/>
        </p:nvSpPr>
        <p:spPr>
          <a:xfrm>
            <a:off x="600295" y="3829951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C25618A-51DF-4290-8849-D99D0F351F40}"/>
              </a:ext>
            </a:extLst>
          </p:cNvPr>
          <p:cNvSpPr txBox="1"/>
          <p:nvPr/>
        </p:nvSpPr>
        <p:spPr>
          <a:xfrm>
            <a:off x="687326" y="4202624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9C554F8-A416-48D5-84F2-F229F48578A0}"/>
              </a:ext>
            </a:extLst>
          </p:cNvPr>
          <p:cNvSpPr txBox="1"/>
          <p:nvPr/>
        </p:nvSpPr>
        <p:spPr>
          <a:xfrm>
            <a:off x="514729" y="4894083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1729780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그림 17">
            <a:extLst>
              <a:ext uri="{FF2B5EF4-FFF2-40B4-BE49-F238E27FC236}">
                <a16:creationId xmlns:a16="http://schemas.microsoft.com/office/drawing/2014/main" id="{B2BE448E-D828-4FA6-8D5B-B7DE140C5E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9891" y="3584419"/>
            <a:ext cx="4781550" cy="495300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0E901583-7475-45E2-87E5-302E9DAF6F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39891" y="2189174"/>
            <a:ext cx="4781550" cy="525971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A9A16C25-22CD-4875-B39D-44F1A38A924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48807" y="2877812"/>
            <a:ext cx="4772634" cy="5439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3455D10-53A0-4748-AEA9-895927EBB3BA}"/>
              </a:ext>
            </a:extLst>
          </p:cNvPr>
          <p:cNvSpPr txBox="1"/>
          <p:nvPr/>
        </p:nvSpPr>
        <p:spPr>
          <a:xfrm>
            <a:off x="256067" y="3614148"/>
            <a:ext cx="1078992" cy="380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ko-KR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5FEFD97-C9C5-4BA7-9786-C187CFF1C763}"/>
              </a:ext>
            </a:extLst>
          </p:cNvPr>
          <p:cNvSpPr txBox="1"/>
          <p:nvPr/>
        </p:nvSpPr>
        <p:spPr>
          <a:xfrm>
            <a:off x="352111" y="2242735"/>
            <a:ext cx="1078992" cy="380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63</a:t>
            </a:r>
            <a:endParaRPr lang="ko-KR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36314A3-CCB0-46A7-AC06-4C67F469603E}"/>
              </a:ext>
            </a:extLst>
          </p:cNvPr>
          <p:cNvSpPr txBox="1"/>
          <p:nvPr/>
        </p:nvSpPr>
        <p:spPr>
          <a:xfrm>
            <a:off x="434407" y="2913577"/>
            <a:ext cx="1078992" cy="380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G1</a:t>
            </a:r>
            <a:endParaRPr lang="ko-KR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336D5BA-AFC3-4E70-9BDD-FAA8BAD72868}"/>
              </a:ext>
            </a:extLst>
          </p:cNvPr>
          <p:cNvSpPr txBox="1"/>
          <p:nvPr/>
        </p:nvSpPr>
        <p:spPr>
          <a:xfrm>
            <a:off x="52381" y="4128232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9C27A02-0824-479B-B76D-F13081ABE1EC}"/>
              </a:ext>
            </a:extLst>
          </p:cNvPr>
          <p:cNvSpPr txBox="1"/>
          <p:nvPr/>
        </p:nvSpPr>
        <p:spPr>
          <a:xfrm>
            <a:off x="126359" y="4489992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1CDCFD0-B55E-4B8A-BE40-6A0532DBB6C9}"/>
              </a:ext>
            </a:extLst>
          </p:cNvPr>
          <p:cNvSpPr txBox="1"/>
          <p:nvPr/>
        </p:nvSpPr>
        <p:spPr>
          <a:xfrm>
            <a:off x="297247" y="4851752"/>
            <a:ext cx="12715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risin (20 nM)</a:t>
            </a:r>
            <a:endParaRPr lang="ko-KR" altLang="en-US" sz="14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1623822-673C-4FBF-8C2D-4E9D29EFDC4B}"/>
              </a:ext>
            </a:extLst>
          </p:cNvPr>
          <p:cNvSpPr txBox="1"/>
          <p:nvPr/>
        </p:nvSpPr>
        <p:spPr>
          <a:xfrm>
            <a:off x="-64526" y="5197255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  <p:graphicFrame>
        <p:nvGraphicFramePr>
          <p:cNvPr id="27" name="표 26">
            <a:extLst>
              <a:ext uri="{FF2B5EF4-FFF2-40B4-BE49-F238E27FC236}">
                <a16:creationId xmlns:a16="http://schemas.microsoft.com/office/drawing/2014/main" id="{FA66CDCF-8F5E-4BE6-B2A3-299DEB53E4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328761"/>
              </p:ext>
            </p:extLst>
          </p:nvPr>
        </p:nvGraphicFramePr>
        <p:xfrm>
          <a:off x="1318163" y="4079719"/>
          <a:ext cx="478155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96925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623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623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623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623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sp>
        <p:nvSpPr>
          <p:cNvPr id="31" name="TextBox 30">
            <a:extLst>
              <a:ext uri="{FF2B5EF4-FFF2-40B4-BE49-F238E27FC236}">
                <a16:creationId xmlns:a16="http://schemas.microsoft.com/office/drawing/2014/main" id="{71A12452-406E-4012-8536-EF3B71CAE034}"/>
              </a:ext>
            </a:extLst>
          </p:cNvPr>
          <p:cNvSpPr txBox="1"/>
          <p:nvPr/>
        </p:nvSpPr>
        <p:spPr>
          <a:xfrm>
            <a:off x="6335998" y="3527958"/>
            <a:ext cx="1078992" cy="380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ko-KR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287F60F-4DAD-4BA8-BEF1-14302F130B5E}"/>
              </a:ext>
            </a:extLst>
          </p:cNvPr>
          <p:cNvSpPr txBox="1"/>
          <p:nvPr/>
        </p:nvSpPr>
        <p:spPr>
          <a:xfrm>
            <a:off x="6432042" y="2156545"/>
            <a:ext cx="1078992" cy="380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63</a:t>
            </a:r>
            <a:endParaRPr lang="ko-KR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77136E0-1351-4472-9AE7-2D5804398019}"/>
              </a:ext>
            </a:extLst>
          </p:cNvPr>
          <p:cNvSpPr txBox="1"/>
          <p:nvPr/>
        </p:nvSpPr>
        <p:spPr>
          <a:xfrm>
            <a:off x="6514338" y="2827387"/>
            <a:ext cx="1078992" cy="3809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G1</a:t>
            </a:r>
            <a:endParaRPr lang="ko-KR" altLang="en-US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8" name="표 37">
            <a:extLst>
              <a:ext uri="{FF2B5EF4-FFF2-40B4-BE49-F238E27FC236}">
                <a16:creationId xmlns:a16="http://schemas.microsoft.com/office/drawing/2014/main" id="{E60C3B1F-E816-499A-9DD7-F04DC50320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3573626"/>
              </p:ext>
            </p:extLst>
          </p:nvPr>
        </p:nvGraphicFramePr>
        <p:xfrm>
          <a:off x="7398094" y="3993529"/>
          <a:ext cx="4781550" cy="14630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96925">
                  <a:extLst>
                    <a:ext uri="{9D8B030D-6E8A-4147-A177-3AD203B41FA5}">
                      <a16:colId xmlns:a16="http://schemas.microsoft.com/office/drawing/2014/main" val="1698787418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535128006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1502375626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3711839253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2516669122"/>
                    </a:ext>
                  </a:extLst>
                </a:gridCol>
                <a:gridCol w="796925">
                  <a:extLst>
                    <a:ext uri="{9D8B030D-6E8A-4147-A177-3AD203B41FA5}">
                      <a16:colId xmlns:a16="http://schemas.microsoft.com/office/drawing/2014/main" val="1172188016"/>
                    </a:ext>
                  </a:extLst>
                </a:gridCol>
              </a:tblGrid>
              <a:tr h="3623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935205"/>
                  </a:ext>
                </a:extLst>
              </a:tr>
              <a:tr h="3623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0340871"/>
                  </a:ext>
                </a:extLst>
              </a:tr>
              <a:tr h="3623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71157502"/>
                  </a:ext>
                </a:extLst>
              </a:tr>
              <a:tr h="36230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-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/>
                        <a:t>+</a:t>
                      </a:r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2166901"/>
                  </a:ext>
                </a:extLst>
              </a:tr>
            </a:tbl>
          </a:graphicData>
        </a:graphic>
      </p:graphicFrame>
      <p:pic>
        <p:nvPicPr>
          <p:cNvPr id="39" name="그림 38">
            <a:extLst>
              <a:ext uri="{FF2B5EF4-FFF2-40B4-BE49-F238E27FC236}">
                <a16:creationId xmlns:a16="http://schemas.microsoft.com/office/drawing/2014/main" id="{E6B0F5C3-256D-4A4A-896D-B5AC61D19E6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10450" y="3455846"/>
            <a:ext cx="4781550" cy="453090"/>
          </a:xfrm>
          <a:prstGeom prst="rect">
            <a:avLst/>
          </a:prstGeom>
        </p:spPr>
      </p:pic>
      <p:pic>
        <p:nvPicPr>
          <p:cNvPr id="40" name="그림 39">
            <a:extLst>
              <a:ext uri="{FF2B5EF4-FFF2-40B4-BE49-F238E27FC236}">
                <a16:creationId xmlns:a16="http://schemas.microsoft.com/office/drawing/2014/main" id="{C9C7A2C6-C6FE-4B5E-B8BB-02AC5E4AE5A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414990" y="2086923"/>
            <a:ext cx="4772635" cy="524989"/>
          </a:xfrm>
          <a:prstGeom prst="rect">
            <a:avLst/>
          </a:prstGeom>
        </p:spPr>
      </p:pic>
      <p:pic>
        <p:nvPicPr>
          <p:cNvPr id="41" name="그림 40">
            <a:extLst>
              <a:ext uri="{FF2B5EF4-FFF2-40B4-BE49-F238E27FC236}">
                <a16:creationId xmlns:a16="http://schemas.microsoft.com/office/drawing/2014/main" id="{0ABE9D0F-B490-45CF-A8A7-242260432F9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414990" y="2742703"/>
            <a:ext cx="4781551" cy="547978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233AD0F0-45E6-47FF-9C13-009A42ED18C0}"/>
              </a:ext>
            </a:extLst>
          </p:cNvPr>
          <p:cNvSpPr txBox="1"/>
          <p:nvPr/>
        </p:nvSpPr>
        <p:spPr>
          <a:xfrm>
            <a:off x="6062142" y="4762310"/>
            <a:ext cx="1531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/>
              <a:t>OSM (20 ng/mL)</a:t>
            </a:r>
            <a:endParaRPr lang="ko-KR" altLang="en-US"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8A9FBCE-A2A9-46EC-952D-0E178E2A03A6}"/>
              </a:ext>
            </a:extLst>
          </p:cNvPr>
          <p:cNvSpPr txBox="1"/>
          <p:nvPr/>
        </p:nvSpPr>
        <p:spPr>
          <a:xfrm>
            <a:off x="6062142" y="4046933"/>
            <a:ext cx="1531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PMA (10 ng/mL)</a:t>
            </a:r>
            <a:endParaRPr lang="ko-KR" altLang="en-US"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705A6E2-E483-4D73-9891-E0B9E74F555B}"/>
              </a:ext>
            </a:extLst>
          </p:cNvPr>
          <p:cNvSpPr txBox="1"/>
          <p:nvPr/>
        </p:nvSpPr>
        <p:spPr>
          <a:xfrm>
            <a:off x="6149173" y="4419606"/>
            <a:ext cx="14526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IL-4 (30 ng/mL)</a:t>
            </a:r>
            <a:endParaRPr lang="ko-KR" altLang="en-US"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B1B63F6-F233-41DB-ACA9-AFD5A5791EA1}"/>
              </a:ext>
            </a:extLst>
          </p:cNvPr>
          <p:cNvSpPr txBox="1"/>
          <p:nvPr/>
        </p:nvSpPr>
        <p:spPr>
          <a:xfrm>
            <a:off x="5976576" y="5111065"/>
            <a:ext cx="16435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Genistein (25 uM)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651790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211</TotalTime>
  <Words>615</Words>
  <Application>Microsoft Office PowerPoint</Application>
  <PresentationFormat>와이드스크린</PresentationFormat>
  <Paragraphs>384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1" baseType="lpstr">
      <vt:lpstr>맑은 고딕</vt:lpstr>
      <vt:lpstr>Arial</vt:lpstr>
      <vt:lpstr>Calibri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권혜지(식품영양학과)</dc:creator>
  <cp:lastModifiedBy>대우 김</cp:lastModifiedBy>
  <cp:revision>236</cp:revision>
  <dcterms:created xsi:type="dcterms:W3CDTF">2023-05-24T10:50:48Z</dcterms:created>
  <dcterms:modified xsi:type="dcterms:W3CDTF">2024-10-20T02:33:04Z</dcterms:modified>
</cp:coreProperties>
</file>